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1504" r:id="rId2"/>
    <p:sldId id="1505" r:id="rId3"/>
    <p:sldId id="1503" r:id="rId4"/>
    <p:sldId id="1506" r:id="rId5"/>
  </p:sldIdLst>
  <p:sldSz cx="12192000" cy="6858000"/>
  <p:notesSz cx="7010400" cy="9296400"/>
  <p:defaultTextStyle>
    <a:defPPr>
      <a:defRPr lang="en-SA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300"/>
    <a:srgbClr val="0054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04"/>
    <p:restoredTop sz="96327" autoAdjust="0"/>
  </p:normalViewPr>
  <p:slideViewPr>
    <p:cSldViewPr snapToGrid="0" snapToObjects="1">
      <p:cViewPr varScale="1">
        <p:scale>
          <a:sx n="127" d="100"/>
          <a:sy n="127" d="100"/>
        </p:scale>
        <p:origin x="83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S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C170336-16D2-C941-AB08-45A639F51D5B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S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S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991F1F1D-D4B0-DE43-BED7-77A782FBA720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24415714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0B1857-A7E5-4DCC-9DA4-FFA2D301782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513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0B1857-A7E5-4DCC-9DA4-FFA2D301782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8009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0B1857-A7E5-4DCC-9DA4-FFA2D301782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70217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0B1857-A7E5-4DCC-9DA4-FFA2D301782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8171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4C48E4-78F3-DF47-AAB0-C0E0B58CEB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0A5A5AC-5814-9842-87FC-53A19FD4B8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F83CFF-7A22-1E42-B9F5-7492E61C4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C43B84-2173-7241-A483-4BC52A393A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2C2BE3-00A3-6D4D-B859-4B28B978F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260955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58EC2E-739C-0549-982C-59E89C672F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95FE94-4AAC-134B-9FC4-6F5A327F96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7443BA-21BD-1742-AACE-CC15C7C3E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AA1F3E-1279-4C48-9B71-4426C9E11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8C7BE3-A0DD-ED43-9699-6DF3787895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2406677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CD62E26-4A54-2041-B7EA-6F7AF903C0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21BED9-2F91-6741-9390-DC9A7F1514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B7B0CA-4D2E-4D4B-BD5C-5E4672321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9A4CFE-10CC-BA49-8C98-695B4AC65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495313-ED98-F844-8370-E2A3685BD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4294574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5C3026-EE57-5F43-924B-7A7040D594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1C7C7E-51C5-FE4C-8305-0C3E068E1A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86E25-E0D0-DF41-A8C7-E8F47AA4C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281C94-D4AA-9D4E-928C-B866F9B52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795E7B-7F6C-264A-9D00-E0DF7C8B07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2324371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CEAF90-EC78-464E-B477-576E70CE82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3686FF-60AC-FF43-BF7B-FEEE66BA42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4537C7-C2E4-A441-8465-564F94E87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1EC9B6-F523-D245-9D00-3E2F45B3F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6FC17C-A733-E84D-8FDB-BB1E31BDFD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323117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1473A-5B18-B349-BF8D-895AAE605C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0B6B79-AEC7-E74C-B69E-4ECBDD348F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92E08B-E42E-1044-B4E5-082FD08D55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B68C63-1DE6-254F-9D38-C186932CA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567722-D4EE-D54D-83CA-576C9315C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164F9A-B214-3F41-B7F6-5E93EA8D2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2235800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5679FE-6BC2-264E-A99D-056873F9E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3CE4DA-000E-7546-B01E-BF548BAB10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839216-C677-0543-AAFE-4E474E4F36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316FBA6-9D81-994E-BCAD-639556FB3F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7B276DF-A11C-174A-B6E9-B1BC5C8C08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7DEF9F-5785-9A41-A828-BFF5E2F1AB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AFA49F2-33D0-B147-A7A6-94EBD7BEB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CDAD386-B2CC-FB45-9F3F-EFA156B6A3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317270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AF706A-1B3C-EB4F-B7D5-D67F1741D9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FF0315-747B-6542-A7DC-4E7DA62D2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CE734E9-A386-8345-8712-28229D0B6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1A73AE-BFA0-6540-B758-0E66C44AD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2748809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A89283-D496-6A42-BBDE-6F2E4B005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217654-E708-7242-B984-26A62D17D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6560A5-AED4-9144-B978-C1A99FAC2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3782547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844021-588A-EC4B-B03A-1C08F6B4C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08E26F-86E5-9A45-B928-7EDBE9AE32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445340-B449-6448-9C48-43E106602B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30008A-684F-E845-BA17-5B32A94E5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32FAA4-97ED-9941-BC98-EBB6808E5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FB160E-392E-C34F-A89A-EF8C444E8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2569975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B024-9800-734B-97AC-9EA615138C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89340F5-5BF3-D941-89F4-EB0B89B61B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S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F597EA-2D6F-5144-9CDF-5F7D45ACE2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2056EA-81A7-AF4F-84BE-35F53AD18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E9F97E-873C-AC48-9F28-49BC0C993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168EF3-2AF3-3D4F-AD6D-C768CAAF2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471613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A0C83CA-A236-F14B-B8C4-7A2BC0ADDE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8B0223-DB36-B74A-8968-CF8E15FA02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83862B-A17D-984B-A689-E191EE4C43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30AF1-E080-0446-A444-FEE6CFA74274}" type="datetimeFigureOut">
              <a:rPr lang="en-SA" smtClean="0"/>
              <a:t>07/04/2023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9CED04-2A1C-AF45-A70A-C93485D8F8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76D48D-F8C8-7142-974A-E5089BF730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B40BD4-0D36-BE45-82C6-95B1FAC57495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2032201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A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FE3B83C-6D71-5DC1-FABB-68DB0E80B091}"/>
              </a:ext>
            </a:extLst>
          </p:cNvPr>
          <p:cNvSpPr txBox="1"/>
          <p:nvPr/>
        </p:nvSpPr>
        <p:spPr>
          <a:xfrm>
            <a:off x="73572" y="5507887"/>
            <a:ext cx="12192000" cy="13501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FIGURE S1: </a:t>
            </a:r>
            <a:r>
              <a:rPr lang="en-US" sz="1400" i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In vitro </a:t>
            </a:r>
            <a:r>
              <a:rPr lang="en-US" sz="14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Striga germination in response to strigolactone analogs ± fluridone. The strigolactone analogs </a:t>
            </a:r>
            <a:r>
              <a:rPr lang="en-US" sz="14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M</a:t>
            </a:r>
            <a:r>
              <a:rPr lang="en-US" sz="14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ethyl </a:t>
            </a:r>
            <a:r>
              <a:rPr lang="en-US" sz="1400" dirty="0" err="1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Phenlactonoate</a:t>
            </a:r>
            <a:r>
              <a:rPr lang="en-US" sz="14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3 and GR24 were applied </a:t>
            </a:r>
            <a:r>
              <a:rPr lang="en-US" sz="14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alone (at 1.0 μM) or along with fluridone (at 1.0 μM) on un-conditioned ( for 72 h) and 10 days conditioned (for 24 h) Striga seeds and germination  percentage was calculated. </a:t>
            </a:r>
            <a:r>
              <a:rPr lang="en-US" sz="14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The bars represent means ± SE (n = 5). The treatments with various letters differ significantly according to one-way ANOVA and Tukey’s post hoc test (p &lt;0.05). Error bars represent the standard error of the mean.</a:t>
            </a:r>
            <a:endParaRPr lang="en-SA" sz="14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FF35D69-AB78-81EE-75F9-C8FB8D93C4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52589" y="110532"/>
            <a:ext cx="4158464" cy="551556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DF5B6D2-0C15-77E9-0933-C6FF5552F450}"/>
              </a:ext>
            </a:extLst>
          </p:cNvPr>
          <p:cNvSpPr txBox="1"/>
          <p:nvPr/>
        </p:nvSpPr>
        <p:spPr>
          <a:xfrm>
            <a:off x="4843303" y="364682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D1EC516-C650-6D51-8EA1-424159A73830}"/>
              </a:ext>
            </a:extLst>
          </p:cNvPr>
          <p:cNvSpPr txBox="1"/>
          <p:nvPr/>
        </p:nvSpPr>
        <p:spPr>
          <a:xfrm>
            <a:off x="6647274" y="368193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EB8B1BC-5D0C-ACDC-BA87-996AE46AD61D}"/>
              </a:ext>
            </a:extLst>
          </p:cNvPr>
          <p:cNvSpPr txBox="1"/>
          <p:nvPr/>
        </p:nvSpPr>
        <p:spPr>
          <a:xfrm>
            <a:off x="5102175" y="339985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03D7633-1037-0849-0C14-4B427E795B7E}"/>
              </a:ext>
            </a:extLst>
          </p:cNvPr>
          <p:cNvSpPr txBox="1"/>
          <p:nvPr/>
        </p:nvSpPr>
        <p:spPr>
          <a:xfrm>
            <a:off x="6924164" y="343396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5560955-2323-02EC-EC6A-A2D3339407DF}"/>
              </a:ext>
            </a:extLst>
          </p:cNvPr>
          <p:cNvSpPr txBox="1"/>
          <p:nvPr/>
        </p:nvSpPr>
        <p:spPr>
          <a:xfrm>
            <a:off x="5341657" y="3295466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d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29581BF-DC5A-879A-170D-35DDCD6E732E}"/>
              </a:ext>
            </a:extLst>
          </p:cNvPr>
          <p:cNvSpPr txBox="1"/>
          <p:nvPr/>
        </p:nvSpPr>
        <p:spPr>
          <a:xfrm>
            <a:off x="5604587" y="3226802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d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035CFC4-31C1-0E27-C658-A76BB3154F50}"/>
              </a:ext>
            </a:extLst>
          </p:cNvPr>
          <p:cNvSpPr txBox="1"/>
          <p:nvPr/>
        </p:nvSpPr>
        <p:spPr>
          <a:xfrm>
            <a:off x="5863659" y="2729816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2F648AC-E766-9C68-6C6D-90ABECC3CC37}"/>
              </a:ext>
            </a:extLst>
          </p:cNvPr>
          <p:cNvSpPr txBox="1"/>
          <p:nvPr/>
        </p:nvSpPr>
        <p:spPr>
          <a:xfrm>
            <a:off x="6199960" y="232108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B00B33E-61CD-1CA7-B42F-3F5BC1A81B11}"/>
              </a:ext>
            </a:extLst>
          </p:cNvPr>
          <p:cNvSpPr txBox="1"/>
          <p:nvPr/>
        </p:nvSpPr>
        <p:spPr>
          <a:xfrm>
            <a:off x="7193790" y="130651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8DDF62F-5ED8-0AB9-E10E-BDB74DC8629E}"/>
              </a:ext>
            </a:extLst>
          </p:cNvPr>
          <p:cNvSpPr txBox="1"/>
          <p:nvPr/>
        </p:nvSpPr>
        <p:spPr>
          <a:xfrm>
            <a:off x="7473034" y="70528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8C0EB60-C6BE-9116-5E6F-7739306B2625}"/>
              </a:ext>
            </a:extLst>
          </p:cNvPr>
          <p:cNvSpPr txBox="1"/>
          <p:nvPr/>
        </p:nvSpPr>
        <p:spPr>
          <a:xfrm>
            <a:off x="8007273" y="50750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3FFD43D-BE0E-570A-C3D2-F29342741007}"/>
              </a:ext>
            </a:extLst>
          </p:cNvPr>
          <p:cNvSpPr txBox="1"/>
          <p:nvPr/>
        </p:nvSpPr>
        <p:spPr>
          <a:xfrm>
            <a:off x="7687837" y="883700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3018FE8-E6BC-0722-1602-2F5477F1D69C}"/>
              </a:ext>
            </a:extLst>
          </p:cNvPr>
          <p:cNvSpPr txBox="1"/>
          <p:nvPr/>
        </p:nvSpPr>
        <p:spPr>
          <a:xfrm>
            <a:off x="954593" y="71343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3065279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FE3B83C-6D71-5DC1-FABB-68DB0E80B091}"/>
              </a:ext>
            </a:extLst>
          </p:cNvPr>
          <p:cNvSpPr txBox="1"/>
          <p:nvPr/>
        </p:nvSpPr>
        <p:spPr>
          <a:xfrm>
            <a:off x="73572" y="5507887"/>
            <a:ext cx="12192000" cy="7037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FIGURE S2: </a:t>
            </a:r>
            <a:r>
              <a:rPr lang="en-US" sz="14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The expression of key genes associated with ABA reception and catabolism in unconditioned and conditioned Striga seeds upon FL ±rac-GR24 application. Asterisks denote significance (one-way ANOVA, *p &lt;0.05, **p &lt;0.005, ***p &lt;0.005, ****p &lt;0.0005). Data are shown as ±STDEV (n=4).</a:t>
            </a:r>
            <a:endParaRPr lang="en-SA" sz="14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C5D1392-0E3D-9B5F-357C-F326DAA801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5529" y="90535"/>
            <a:ext cx="4680408" cy="5554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37029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FE3B83C-6D71-5DC1-FABB-68DB0E80B091}"/>
              </a:ext>
            </a:extLst>
          </p:cNvPr>
          <p:cNvSpPr txBox="1"/>
          <p:nvPr/>
        </p:nvSpPr>
        <p:spPr>
          <a:xfrm>
            <a:off x="73572" y="5507887"/>
            <a:ext cx="12192000" cy="1350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FIGURE S3: </a:t>
            </a:r>
            <a:r>
              <a:rPr lang="en-US" sz="14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Effect of pre-germinated Striga seeds ± ABA on root growth of rice seedlings.</a:t>
            </a:r>
            <a:r>
              <a:rPr lang="en-US" sz="1400" b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(A) Roots of rice seedlings co-cultured with Striga ± ABA (5 µM). (B) Root length (C) Crown roots and (D) Lateral roots of rice seedlings co-cultured with Striga ± ABA. Each data point represents one plant (n = 8). Data represent means ± SE. The treatments with various letters differ significantly according to one-way ANOVA and Tukey’s post hoc test (p &lt;0.05). Error bars represent the standard error of the mean.</a:t>
            </a:r>
            <a:endParaRPr lang="en-SA" sz="14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B6A44599-5965-2273-20DD-FB9603AD150C}"/>
              </a:ext>
            </a:extLst>
          </p:cNvPr>
          <p:cNvGrpSpPr/>
          <p:nvPr/>
        </p:nvGrpSpPr>
        <p:grpSpPr>
          <a:xfrm>
            <a:off x="2313939" y="0"/>
            <a:ext cx="6715413" cy="5588426"/>
            <a:chOff x="1681512" y="-3118"/>
            <a:chExt cx="6715413" cy="5588426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A66BCCC-E3FD-7183-0B10-B9741F8449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055" t="2481" r="52440" b="67841"/>
            <a:stretch/>
          </p:blipFill>
          <p:spPr>
            <a:xfrm>
              <a:off x="2215131" y="0"/>
              <a:ext cx="5395823" cy="217859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BDF2F27-2D83-2579-0882-F3D59D7CB69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19612" y="2181708"/>
              <a:ext cx="2387600" cy="34036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91C8820-4FE8-5015-84E5-A9A6D2C03C6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00193" y="2181708"/>
              <a:ext cx="2425700" cy="34036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8C8C3AB-0809-8185-C6CE-EF5C52A4EEE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742625" y="2181708"/>
              <a:ext cx="2654300" cy="31496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BDA13E2-47C9-B4E7-2158-38E2AFEF64AB}"/>
                </a:ext>
              </a:extLst>
            </p:cNvPr>
            <p:cNvSpPr txBox="1"/>
            <p:nvPr/>
          </p:nvSpPr>
          <p:spPr>
            <a:xfrm>
              <a:off x="1681512" y="2070644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A5B5B1C-DA42-540A-B6C1-6826D88D98D6}"/>
                </a:ext>
              </a:extLst>
            </p:cNvPr>
            <p:cNvSpPr txBox="1"/>
            <p:nvPr/>
          </p:nvSpPr>
          <p:spPr>
            <a:xfrm>
              <a:off x="3700193" y="2135765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0FA78E8-7DB8-A0E9-1719-E95AA26A7C4E}"/>
                </a:ext>
              </a:extLst>
            </p:cNvPr>
            <p:cNvSpPr txBox="1"/>
            <p:nvPr/>
          </p:nvSpPr>
          <p:spPr>
            <a:xfrm>
              <a:off x="5737352" y="2178590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876A810-E15B-D2F9-7D69-CFD81AB9BB41}"/>
                </a:ext>
              </a:extLst>
            </p:cNvPr>
            <p:cNvSpPr txBox="1"/>
            <p:nvPr/>
          </p:nvSpPr>
          <p:spPr>
            <a:xfrm>
              <a:off x="2913412" y="2803007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94A0CE7-8A34-A9B6-3333-D141FED4CC08}"/>
                </a:ext>
              </a:extLst>
            </p:cNvPr>
            <p:cNvSpPr txBox="1"/>
            <p:nvPr/>
          </p:nvSpPr>
          <p:spPr>
            <a:xfrm>
              <a:off x="2510332" y="222124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BE2F26E-E6FA-5A1F-3ED0-680130D966C5}"/>
                </a:ext>
              </a:extLst>
            </p:cNvPr>
            <p:cNvSpPr txBox="1"/>
            <p:nvPr/>
          </p:nvSpPr>
          <p:spPr>
            <a:xfrm>
              <a:off x="3323342" y="223457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29C6F5C-80C2-383B-A158-71C8F5D97085}"/>
                </a:ext>
              </a:extLst>
            </p:cNvPr>
            <p:cNvSpPr txBox="1"/>
            <p:nvPr/>
          </p:nvSpPr>
          <p:spPr>
            <a:xfrm>
              <a:off x="6911315" y="2989612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7182ED6-472A-BA3B-4808-946D36F149E4}"/>
                </a:ext>
              </a:extLst>
            </p:cNvPr>
            <p:cNvSpPr txBox="1"/>
            <p:nvPr/>
          </p:nvSpPr>
          <p:spPr>
            <a:xfrm>
              <a:off x="7626493" y="248636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C8B1606-8EA8-AC8D-68EF-C50AC6EB86D6}"/>
                </a:ext>
              </a:extLst>
            </p:cNvPr>
            <p:cNvSpPr txBox="1"/>
            <p:nvPr/>
          </p:nvSpPr>
          <p:spPr>
            <a:xfrm>
              <a:off x="5342914" y="216654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976564A0-BA9A-0619-01C0-D928C5B93CEA}"/>
                </a:ext>
              </a:extLst>
            </p:cNvPr>
            <p:cNvCxnSpPr>
              <a:cxnSpLocks/>
            </p:cNvCxnSpPr>
            <p:nvPr/>
          </p:nvCxnSpPr>
          <p:spPr>
            <a:xfrm>
              <a:off x="4476016" y="2965862"/>
              <a:ext cx="747358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C34139C-A23C-8B6D-79B8-E88175DD9F33}"/>
                </a:ext>
              </a:extLst>
            </p:cNvPr>
            <p:cNvSpPr txBox="1"/>
            <p:nvPr/>
          </p:nvSpPr>
          <p:spPr>
            <a:xfrm>
              <a:off x="4693173" y="2688863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219141F-CFA5-C01E-6BCE-D12EF85FA4CF}"/>
                </a:ext>
              </a:extLst>
            </p:cNvPr>
            <p:cNvSpPr txBox="1"/>
            <p:nvPr/>
          </p:nvSpPr>
          <p:spPr>
            <a:xfrm>
              <a:off x="2256321" y="-3118"/>
              <a:ext cx="33214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A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993770B-7032-6D9D-D6B8-65563393A1A1}"/>
                </a:ext>
              </a:extLst>
            </p:cNvPr>
            <p:cNvSpPr txBox="1"/>
            <p:nvPr/>
          </p:nvSpPr>
          <p:spPr>
            <a:xfrm>
              <a:off x="1725045" y="2070644"/>
              <a:ext cx="33214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A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ED17BFE-8058-68A5-922C-693D14E3871F}"/>
                </a:ext>
              </a:extLst>
            </p:cNvPr>
            <p:cNvSpPr txBox="1"/>
            <p:nvPr/>
          </p:nvSpPr>
          <p:spPr>
            <a:xfrm>
              <a:off x="3737527" y="2160479"/>
              <a:ext cx="33214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A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AC4DAEE-97DE-958F-71A1-F7305D920D52}"/>
                </a:ext>
              </a:extLst>
            </p:cNvPr>
            <p:cNvSpPr txBox="1"/>
            <p:nvPr/>
          </p:nvSpPr>
          <p:spPr>
            <a:xfrm>
              <a:off x="5787935" y="2173020"/>
              <a:ext cx="33214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A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851872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6C38815-2F86-313B-31F4-8A7D2B9C95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0174" y="1874067"/>
            <a:ext cx="10512685" cy="273414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CFCA70A-7E0C-E6B7-7900-4FD91E81E8E9}"/>
              </a:ext>
            </a:extLst>
          </p:cNvPr>
          <p:cNvSpPr txBox="1"/>
          <p:nvPr/>
        </p:nvSpPr>
        <p:spPr>
          <a:xfrm>
            <a:off x="857816" y="1874067"/>
            <a:ext cx="6097508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1.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st of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RT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PCR primers used in this work.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SA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2228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930</TotalTime>
  <Words>324</Words>
  <Application>Microsoft Macintosh PowerPoint</Application>
  <PresentationFormat>Widescreen</PresentationFormat>
  <Paragraphs>34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44</cp:revision>
  <cp:lastPrinted>2022-02-19T10:41:20Z</cp:lastPrinted>
  <dcterms:created xsi:type="dcterms:W3CDTF">2021-09-08T20:09:05Z</dcterms:created>
  <dcterms:modified xsi:type="dcterms:W3CDTF">2023-04-06T23:48:49Z</dcterms:modified>
</cp:coreProperties>
</file>